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8"/>
  </p:notesMasterIdLst>
  <p:sldIdLst>
    <p:sldId id="317" r:id="rId2"/>
    <p:sldId id="319" r:id="rId3"/>
    <p:sldId id="325" r:id="rId4"/>
    <p:sldId id="316" r:id="rId5"/>
    <p:sldId id="284" r:id="rId6"/>
    <p:sldId id="322" r:id="rId7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ransplantMC01" initials="T" lastIdx="1" clrIdx="0">
    <p:extLst>
      <p:ext uri="{19B8F6BF-5375-455C-9EA6-DF929625EA0E}">
        <p15:presenceInfo xmlns:p15="http://schemas.microsoft.com/office/powerpoint/2012/main" userId="S-1-5-21-1177238915-1035525444-1606980848-49943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293" autoAdjust="0"/>
    <p:restoredTop sz="96357" autoAdjust="0"/>
  </p:normalViewPr>
  <p:slideViewPr>
    <p:cSldViewPr snapToGrid="0" snapToObjects="1">
      <p:cViewPr varScale="1">
        <p:scale>
          <a:sx n="44" d="100"/>
          <a:sy n="44" d="100"/>
        </p:scale>
        <p:origin x="1668" y="6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80" d="100"/>
        <a:sy n="180" d="100"/>
      </p:scale>
      <p:origin x="0" y="-10896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467D97-078B-F34F-90D7-933BA669C2F2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693813-4281-C04C-9D8C-D200665DE5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1400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9693813-4281-C04C-9D8C-D200665DE53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31310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9693813-4281-C04C-9D8C-D200665DE53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0609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9693813-4281-C04C-9D8C-D200665DE53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039563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9693813-4281-C04C-9D8C-D200665DE532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66546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9693813-4281-C04C-9D8C-D200665DE532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607863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9693813-4281-C04C-9D8C-D200665DE532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09280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3F97-D34E-0843-9287-1EF32E1E59E4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E2D76-1A10-EF46-A3A4-A4A038BF1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5392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3F97-D34E-0843-9287-1EF32E1E59E4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E2D76-1A10-EF46-A3A4-A4A038BF1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8372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3F97-D34E-0843-9287-1EF32E1E59E4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E2D76-1A10-EF46-A3A4-A4A038BF1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032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3F97-D34E-0843-9287-1EF32E1E59E4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E2D76-1A10-EF46-A3A4-A4A038BF1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0932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3F97-D34E-0843-9287-1EF32E1E59E4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E2D76-1A10-EF46-A3A4-A4A038BF1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2191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3F97-D34E-0843-9287-1EF32E1E59E4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E2D76-1A10-EF46-A3A4-A4A038BF1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90052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3F97-D34E-0843-9287-1EF32E1E59E4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E2D76-1A10-EF46-A3A4-A4A038BF1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0187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3F97-D34E-0843-9287-1EF32E1E59E4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E2D76-1A10-EF46-A3A4-A4A038BF1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0889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3F97-D34E-0843-9287-1EF32E1E59E4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E2D76-1A10-EF46-A3A4-A4A038BF1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408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3F97-D34E-0843-9287-1EF32E1E59E4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E2D76-1A10-EF46-A3A4-A4A038BF1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8892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43F97-D34E-0843-9287-1EF32E1E59E4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E2D76-1A10-EF46-A3A4-A4A038BF1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187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443F97-D34E-0843-9287-1EF32E1E59E4}" type="datetimeFigureOut">
              <a:rPr lang="en-US" smtClean="0"/>
              <a:t>1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1E2D76-1A10-EF46-A3A4-A4A038BF1E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5034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12" Type="http://schemas.openxmlformats.org/officeDocument/2006/relationships/image" Target="../media/image1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diagram of different colored objects&#10;&#10;Description automatically generated">
            <a:extLst>
              <a:ext uri="{FF2B5EF4-FFF2-40B4-BE49-F238E27FC236}">
                <a16:creationId xmlns:a16="http://schemas.microsoft.com/office/drawing/2014/main" id="{29E09798-721E-6A7E-87B5-55FDF81C2A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38485" y="872540"/>
            <a:ext cx="2743201" cy="1828800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CAF6F206-F79A-E248-B9AA-9160CA1BE0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5915025" cy="541867"/>
          </a:xfrm>
        </p:spPr>
        <p:txBody>
          <a:bodyPr>
            <a:normAutofit/>
          </a:bodyPr>
          <a:lstStyle/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10E01AC-D217-ED42-A688-17F8E71CDF6E}"/>
              </a:ext>
            </a:extLst>
          </p:cNvPr>
          <p:cNvSpPr txBox="1"/>
          <p:nvPr/>
        </p:nvSpPr>
        <p:spPr>
          <a:xfrm>
            <a:off x="99946" y="3012721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3E9CA3A-34EE-8447-AF59-FD77C058A3CD}"/>
              </a:ext>
            </a:extLst>
          </p:cNvPr>
          <p:cNvSpPr txBox="1"/>
          <p:nvPr/>
        </p:nvSpPr>
        <p:spPr>
          <a:xfrm>
            <a:off x="90584" y="768191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0B6FA05-D655-AD48-BBF7-2EC763C7DD1B}"/>
              </a:ext>
            </a:extLst>
          </p:cNvPr>
          <p:cNvSpPr txBox="1"/>
          <p:nvPr/>
        </p:nvSpPr>
        <p:spPr>
          <a:xfrm>
            <a:off x="3357088" y="677136"/>
            <a:ext cx="507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458B5C6-8794-78EA-25B3-DEB1E52B56F4}"/>
              </a:ext>
            </a:extLst>
          </p:cNvPr>
          <p:cNvSpPr txBox="1"/>
          <p:nvPr/>
        </p:nvSpPr>
        <p:spPr>
          <a:xfrm>
            <a:off x="113246" y="5553819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FA40002-7A4B-9995-707C-0077CDE91EF7}"/>
              </a:ext>
            </a:extLst>
          </p:cNvPr>
          <p:cNvSpPr txBox="1"/>
          <p:nvPr/>
        </p:nvSpPr>
        <p:spPr>
          <a:xfrm>
            <a:off x="3409808" y="2547372"/>
            <a:ext cx="4552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DFB1A9C-88E1-294E-B6EB-583F9F39F1BB}"/>
              </a:ext>
            </a:extLst>
          </p:cNvPr>
          <p:cNvSpPr txBox="1"/>
          <p:nvPr/>
        </p:nvSpPr>
        <p:spPr>
          <a:xfrm>
            <a:off x="3343655" y="4616009"/>
            <a:ext cx="381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E4C3A34-4934-9301-E193-F187DFE1C976}"/>
              </a:ext>
            </a:extLst>
          </p:cNvPr>
          <p:cNvSpPr txBox="1"/>
          <p:nvPr/>
        </p:nvSpPr>
        <p:spPr>
          <a:xfrm>
            <a:off x="3329205" y="6500547"/>
            <a:ext cx="4532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A921693-FA57-E2D7-397A-6D29F8F2A3D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9728" y="934473"/>
            <a:ext cx="3150413" cy="229697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90B047A-5A67-C4B3-9D52-C8866B112C1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23056" y="2787209"/>
            <a:ext cx="2808907" cy="18288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56FDAB89-388F-C3F0-756F-B87042B3B1C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82456" y="4765383"/>
            <a:ext cx="2731980" cy="18288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B36464E3-AAD3-512B-0FF1-D7E89315FA9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82456" y="6638064"/>
            <a:ext cx="2805290" cy="18288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0FA6ADDE-B2EB-6F7E-B647-A00B2E91766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73736" y="5559552"/>
            <a:ext cx="2659837" cy="2350389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3B7661FD-54F0-00D4-B197-418F3405DBE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3736" y="3163824"/>
            <a:ext cx="2528316" cy="23042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97822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66C3704-68D4-E51B-9CD7-E0DBEC5C9385}"/>
              </a:ext>
            </a:extLst>
          </p:cNvPr>
          <p:cNvSpPr txBox="1"/>
          <p:nvPr/>
        </p:nvSpPr>
        <p:spPr>
          <a:xfrm>
            <a:off x="28250" y="50800"/>
            <a:ext cx="2723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.</a:t>
            </a:r>
          </a:p>
        </p:txBody>
      </p:sp>
      <p:pic>
        <p:nvPicPr>
          <p:cNvPr id="8" name="Picture 7" descr="A colorful squares with black and white text&#10;&#10;Description automatically generated">
            <a:extLst>
              <a:ext uri="{FF2B5EF4-FFF2-40B4-BE49-F238E27FC236}">
                <a16:creationId xmlns:a16="http://schemas.microsoft.com/office/drawing/2014/main" id="{7439132F-1E32-D94C-A566-3A4C580E0E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3007" y="536550"/>
            <a:ext cx="4754926" cy="8556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21939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4A6C8C-4F6C-7E7E-E949-0EEC1E51575C}"/>
              </a:ext>
            </a:extLst>
          </p:cNvPr>
          <p:cNvSpPr txBox="1">
            <a:spLocks/>
          </p:cNvSpPr>
          <p:nvPr/>
        </p:nvSpPr>
        <p:spPr>
          <a:xfrm>
            <a:off x="150836" y="144943"/>
            <a:ext cx="5915025" cy="27146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3.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9420F78-CB74-5844-B87B-3534E42B9845}"/>
              </a:ext>
            </a:extLst>
          </p:cNvPr>
          <p:cNvSpPr txBox="1"/>
          <p:nvPr/>
        </p:nvSpPr>
        <p:spPr>
          <a:xfrm>
            <a:off x="49072" y="575434"/>
            <a:ext cx="37573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SEA: Hallmark Cholesterol homeostasis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3A95B13-BFEB-F544-A5FE-61CC8ECC3557}"/>
              </a:ext>
            </a:extLst>
          </p:cNvPr>
          <p:cNvSpPr txBox="1"/>
          <p:nvPr/>
        </p:nvSpPr>
        <p:spPr>
          <a:xfrm>
            <a:off x="105567" y="4865486"/>
            <a:ext cx="30899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SEA: Hallmark Adipogenesis</a:t>
            </a:r>
          </a:p>
        </p:txBody>
      </p:sp>
      <p:grpSp>
        <p:nvGrpSpPr>
          <p:cNvPr id="49" name="Group 48">
            <a:extLst>
              <a:ext uri="{FF2B5EF4-FFF2-40B4-BE49-F238E27FC236}">
                <a16:creationId xmlns:a16="http://schemas.microsoft.com/office/drawing/2014/main" id="{4C405B01-D958-D747-A7FE-33C941DDAB04}"/>
              </a:ext>
            </a:extLst>
          </p:cNvPr>
          <p:cNvGrpSpPr/>
          <p:nvPr/>
        </p:nvGrpSpPr>
        <p:grpSpPr>
          <a:xfrm>
            <a:off x="514901" y="6037697"/>
            <a:ext cx="1645920" cy="1916639"/>
            <a:chOff x="493886" y="4946103"/>
            <a:chExt cx="1645920" cy="1916639"/>
          </a:xfrm>
        </p:grpSpPr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826772A0-A62C-544A-9859-CE75883B81C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93886" y="5216822"/>
              <a:ext cx="1645920" cy="1645920"/>
            </a:xfrm>
            <a:prstGeom prst="rect">
              <a:avLst/>
            </a:prstGeom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0E8A86AC-BC35-0647-9A76-129DAC2FBFE7}"/>
                </a:ext>
              </a:extLst>
            </p:cNvPr>
            <p:cNvSpPr txBox="1"/>
            <p:nvPr/>
          </p:nvSpPr>
          <p:spPr>
            <a:xfrm>
              <a:off x="493886" y="4946103"/>
              <a:ext cx="16459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ASH vs ND</a:t>
              </a:r>
            </a:p>
          </p:txBody>
        </p: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EE8E393B-8908-A84F-929B-0C7632394E36}"/>
              </a:ext>
            </a:extLst>
          </p:cNvPr>
          <p:cNvGrpSpPr/>
          <p:nvPr/>
        </p:nvGrpSpPr>
        <p:grpSpPr>
          <a:xfrm>
            <a:off x="514901" y="1807414"/>
            <a:ext cx="1645920" cy="1902121"/>
            <a:chOff x="179561" y="678878"/>
            <a:chExt cx="1645920" cy="1902121"/>
          </a:xfrm>
        </p:grpSpPr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5D8D125A-7C49-1C4C-9EF2-459DB28EA7BF}"/>
                </a:ext>
              </a:extLst>
            </p:cNvPr>
            <p:cNvSpPr txBox="1"/>
            <p:nvPr/>
          </p:nvSpPr>
          <p:spPr>
            <a:xfrm>
              <a:off x="179561" y="678878"/>
              <a:ext cx="16459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ASH vs ND</a:t>
              </a:r>
            </a:p>
          </p:txBody>
        </p:sp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15D2BAEB-1B04-CF44-B449-2855CD1ED65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79561" y="935079"/>
              <a:ext cx="1645920" cy="1645920"/>
            </a:xfrm>
            <a:prstGeom prst="rect">
              <a:avLst/>
            </a:prstGeom>
          </p:spPr>
        </p:pic>
      </p:grpSp>
      <p:sp>
        <p:nvSpPr>
          <p:cNvPr id="55" name="TextBox 54">
            <a:extLst>
              <a:ext uri="{FF2B5EF4-FFF2-40B4-BE49-F238E27FC236}">
                <a16:creationId xmlns:a16="http://schemas.microsoft.com/office/drawing/2014/main" id="{EB17E010-EDFA-EE41-A4FA-282402804FA3}"/>
              </a:ext>
            </a:extLst>
          </p:cNvPr>
          <p:cNvSpPr txBox="1"/>
          <p:nvPr/>
        </p:nvSpPr>
        <p:spPr>
          <a:xfrm>
            <a:off x="2370448" y="903374"/>
            <a:ext cx="224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SH +  5% Mannose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3C7DA73-FA79-C743-98A8-0F98B1F50A31}"/>
              </a:ext>
            </a:extLst>
          </p:cNvPr>
          <p:cNvSpPr txBox="1"/>
          <p:nvPr/>
        </p:nvSpPr>
        <p:spPr>
          <a:xfrm>
            <a:off x="4427063" y="903374"/>
            <a:ext cx="224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SH +  20% Mannose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923D94E-0B1D-3748-BE67-EC141DE7AE77}"/>
              </a:ext>
            </a:extLst>
          </p:cNvPr>
          <p:cNvSpPr txBox="1"/>
          <p:nvPr/>
        </p:nvSpPr>
        <p:spPr>
          <a:xfrm rot="16200000">
            <a:off x="1762993" y="1911134"/>
            <a:ext cx="1576977" cy="2770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REVENTION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43BA184-4AFA-FC4C-914C-54873D9C2FA1}"/>
              </a:ext>
            </a:extLst>
          </p:cNvPr>
          <p:cNvSpPr txBox="1"/>
          <p:nvPr/>
        </p:nvSpPr>
        <p:spPr>
          <a:xfrm rot="16200000">
            <a:off x="1765284" y="3868044"/>
            <a:ext cx="15723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VERSAL</a:t>
            </a:r>
          </a:p>
        </p:txBody>
      </p:sp>
      <p:pic>
        <p:nvPicPr>
          <p:cNvPr id="59" name="Picture 10">
            <a:extLst>
              <a:ext uri="{FF2B5EF4-FFF2-40B4-BE49-F238E27FC236}">
                <a16:creationId xmlns:a16="http://schemas.microsoft.com/office/drawing/2014/main" id="{1CF7483C-F9ED-CD4C-9346-B36829C1592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30984" y="1246944"/>
            <a:ext cx="164592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0" name="Picture 2">
            <a:extLst>
              <a:ext uri="{FF2B5EF4-FFF2-40B4-BE49-F238E27FC236}">
                <a16:creationId xmlns:a16="http://schemas.microsoft.com/office/drawing/2014/main" id="{2360D591-F809-4643-82CD-B5801E73287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3310" y="1246944"/>
            <a:ext cx="164592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F0CEC13B-606C-4D4C-A41B-B62B8D0FB1C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30984" y="3200099"/>
            <a:ext cx="1645920" cy="1645920"/>
          </a:xfrm>
          <a:prstGeom prst="rect">
            <a:avLst/>
          </a:prstGeom>
        </p:spPr>
      </p:pic>
      <p:pic>
        <p:nvPicPr>
          <p:cNvPr id="62" name="Picture 6">
            <a:extLst>
              <a:ext uri="{FF2B5EF4-FFF2-40B4-BE49-F238E27FC236}">
                <a16:creationId xmlns:a16="http://schemas.microsoft.com/office/drawing/2014/main" id="{7277531B-42E8-F64E-8762-CED1F3B9D79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9702" y="3199714"/>
            <a:ext cx="164592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401F8AE1-A929-004F-97C3-CD4819FA1E84}"/>
              </a:ext>
            </a:extLst>
          </p:cNvPr>
          <p:cNvSpPr txBox="1"/>
          <p:nvPr/>
        </p:nvSpPr>
        <p:spPr>
          <a:xfrm>
            <a:off x="2412979" y="5117419"/>
            <a:ext cx="224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SH +  5% Mannose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234B267-BB36-A64B-A929-FB87BCDC56FF}"/>
              </a:ext>
            </a:extLst>
          </p:cNvPr>
          <p:cNvSpPr txBox="1"/>
          <p:nvPr/>
        </p:nvSpPr>
        <p:spPr>
          <a:xfrm>
            <a:off x="4469594" y="5117419"/>
            <a:ext cx="224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SH +  20% Mannose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D3839CB3-811F-3C4A-A0B7-BC12FC82C957}"/>
              </a:ext>
            </a:extLst>
          </p:cNvPr>
          <p:cNvSpPr txBox="1"/>
          <p:nvPr/>
        </p:nvSpPr>
        <p:spPr>
          <a:xfrm rot="16200000">
            <a:off x="1795498" y="6135206"/>
            <a:ext cx="1595381" cy="2753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REVENTION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058CF921-77F5-1C40-A52A-A87F4B57F44A}"/>
              </a:ext>
            </a:extLst>
          </p:cNvPr>
          <p:cNvSpPr txBox="1"/>
          <p:nvPr/>
        </p:nvSpPr>
        <p:spPr>
          <a:xfrm rot="16200000">
            <a:off x="1767105" y="8053825"/>
            <a:ext cx="1652166" cy="2753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VERSAL</a:t>
            </a:r>
          </a:p>
        </p:txBody>
      </p:sp>
      <p:pic>
        <p:nvPicPr>
          <p:cNvPr id="67" name="Picture 12">
            <a:extLst>
              <a:ext uri="{FF2B5EF4-FFF2-40B4-BE49-F238E27FC236}">
                <a16:creationId xmlns:a16="http://schemas.microsoft.com/office/drawing/2014/main" id="{96F61F17-5B93-1249-895D-BECD90101CC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30984" y="5439584"/>
            <a:ext cx="164592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8" name="Picture 4">
            <a:extLst>
              <a:ext uri="{FF2B5EF4-FFF2-40B4-BE49-F238E27FC236}">
                <a16:creationId xmlns:a16="http://schemas.microsoft.com/office/drawing/2014/main" id="{0E5C0E7B-B89F-CC43-9E05-9F0A3255DAB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9702" y="5435232"/>
            <a:ext cx="164592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84943D52-63E6-E249-9985-169B643F512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730984" y="7344015"/>
            <a:ext cx="1645920" cy="1645920"/>
          </a:xfrm>
          <a:prstGeom prst="rect">
            <a:avLst/>
          </a:prstGeom>
        </p:spPr>
      </p:pic>
      <p:pic>
        <p:nvPicPr>
          <p:cNvPr id="70" name="Picture 8">
            <a:extLst>
              <a:ext uri="{FF2B5EF4-FFF2-40B4-BE49-F238E27FC236}">
                <a16:creationId xmlns:a16="http://schemas.microsoft.com/office/drawing/2014/main" id="{F64EB74D-1337-6541-B206-7A05A5B1EED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9702" y="7344015"/>
            <a:ext cx="164592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7542645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EF1C970-CA76-FA4B-9E28-D772DB8B76AF}"/>
              </a:ext>
            </a:extLst>
          </p:cNvPr>
          <p:cNvSpPr txBox="1"/>
          <p:nvPr/>
        </p:nvSpPr>
        <p:spPr>
          <a:xfrm>
            <a:off x="214313" y="400050"/>
            <a:ext cx="2723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S4.</a:t>
            </a:r>
          </a:p>
        </p:txBody>
      </p:sp>
      <p:pic>
        <p:nvPicPr>
          <p:cNvPr id="5" name="Picture 4" descr="A graph of blue and red squares&#10;&#10;Description automatically generated">
            <a:extLst>
              <a:ext uri="{FF2B5EF4-FFF2-40B4-BE49-F238E27FC236}">
                <a16:creationId xmlns:a16="http://schemas.microsoft.com/office/drawing/2014/main" id="{7B4AA5AB-99BE-419F-7995-7B9E5887AF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9579" y="1462589"/>
            <a:ext cx="6010160" cy="33666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64523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1BEE267A-2F96-C14C-866E-47059437B46D}"/>
              </a:ext>
            </a:extLst>
          </p:cNvPr>
          <p:cNvSpPr txBox="1"/>
          <p:nvPr/>
        </p:nvSpPr>
        <p:spPr>
          <a:xfrm>
            <a:off x="85725" y="100013"/>
            <a:ext cx="2463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Table 1.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27679D8F-CB48-F7BC-A7B2-7D671329F339}"/>
              </a:ext>
            </a:extLst>
          </p:cNvPr>
          <p:cNvGrpSpPr/>
          <p:nvPr/>
        </p:nvGrpSpPr>
        <p:grpSpPr>
          <a:xfrm>
            <a:off x="85725" y="1683165"/>
            <a:ext cx="6657535" cy="1749592"/>
            <a:chOff x="85725" y="1683165"/>
            <a:chExt cx="6657535" cy="1749592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35874450-2429-1F17-563B-51009E0BCBF8}"/>
                </a:ext>
              </a:extLst>
            </p:cNvPr>
            <p:cNvSpPr txBox="1"/>
            <p:nvPr/>
          </p:nvSpPr>
          <p:spPr>
            <a:xfrm>
              <a:off x="85725" y="1683165"/>
              <a:ext cx="537198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Supplemental Table 1. Group comparisons for steatosis - Student’s t-test p-values  </a:t>
              </a:r>
            </a:p>
          </p:txBody>
        </p: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12D634AF-C013-885A-B74F-334A4A9FF2B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4225" y="1969717"/>
              <a:ext cx="6619035" cy="146304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2516395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E86D503-E015-8D6F-F67F-22096B253E6C}"/>
              </a:ext>
            </a:extLst>
          </p:cNvPr>
          <p:cNvSpPr txBox="1"/>
          <p:nvPr/>
        </p:nvSpPr>
        <p:spPr>
          <a:xfrm>
            <a:off x="155684" y="189107"/>
            <a:ext cx="25056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Table 2. 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8113595C-1A02-FD52-3F5E-253F0CB48DAD}"/>
              </a:ext>
            </a:extLst>
          </p:cNvPr>
          <p:cNvGrpSpPr/>
          <p:nvPr/>
        </p:nvGrpSpPr>
        <p:grpSpPr>
          <a:xfrm>
            <a:off x="85725" y="1848775"/>
            <a:ext cx="6681859" cy="1517503"/>
            <a:chOff x="85725" y="1848775"/>
            <a:chExt cx="6681859" cy="1517503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C9510B34-236D-1186-38A5-3ADA2EDC99AD}"/>
                </a:ext>
              </a:extLst>
            </p:cNvPr>
            <p:cNvSpPr txBox="1"/>
            <p:nvPr/>
          </p:nvSpPr>
          <p:spPr>
            <a:xfrm>
              <a:off x="85725" y="1848775"/>
              <a:ext cx="541847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Supplemental Table 2. Group comparisons for fibrosis - Student’s t-test p-values  </a:t>
              </a:r>
            </a:p>
          </p:txBody>
        </p: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0FB71AA8-0327-F569-0464-D1E08DAF15D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5725" y="2159270"/>
              <a:ext cx="6681859" cy="120700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9679622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970</TotalTime>
  <Words>107</Words>
  <Application>Microsoft Office PowerPoint</Application>
  <PresentationFormat>Letter Paper (8.5x11 in)</PresentationFormat>
  <Paragraphs>33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Supplemental Figure S1.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 Chu</dc:creator>
  <cp:lastModifiedBy>Hong, John</cp:lastModifiedBy>
  <cp:revision>451</cp:revision>
  <cp:lastPrinted>2023-12-04T20:00:01Z</cp:lastPrinted>
  <dcterms:created xsi:type="dcterms:W3CDTF">2023-02-07T14:01:45Z</dcterms:created>
  <dcterms:modified xsi:type="dcterms:W3CDTF">2024-01-17T16:16:47Z</dcterms:modified>
</cp:coreProperties>
</file>